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ayout>
        <c:manualLayout>
          <c:layoutTarget val="inner"/>
          <c:xMode val="edge"/>
          <c:yMode val="edge"/>
          <c:x val="0.151486486486487"/>
          <c:y val="0.0843478260869565"/>
          <c:w val="0.848378378378378"/>
          <c:h val="0.73369565217391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 w="0">
              <a:solidFill>
                <a:srgbClr val="000000"/>
              </a:solidFill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gapWidth val="30"/>
        <c:overlap val="0"/>
        <c:axId val="18333977"/>
        <c:axId val="44363642"/>
      </c:barChart>
      <c:catAx>
        <c:axId val="18333977"/>
        <c:scaling>
          <c:orientation val="minMax"/>
        </c:scaling>
        <c:delete val="0"/>
        <c:axPos val="b"/>
        <c:numFmt formatCode="[$-3409]mm/dd/yyyy" sourceLinked="1"/>
        <c:majorTickMark val="out"/>
        <c:minorTickMark val="none"/>
        <c:tickLblPos val="nextTo"/>
        <c:spPr>
          <a:ln w="93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44363642"/>
        <c:crosses val="autoZero"/>
        <c:auto val="1"/>
        <c:lblAlgn val="ctr"/>
        <c:lblOffset val="100"/>
        <c:noMultiLvlLbl val="0"/>
      </c:catAx>
      <c:valAx>
        <c:axId val="44363642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3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18333977"/>
        <c:crosses val="autoZero"/>
        <c:crossBetween val="between"/>
        <c:majorUnit val="20"/>
      </c:valAx>
      <c:spPr>
        <a:noFill/>
        <a:ln w="0">
          <a:noFill/>
        </a:ln>
      </c:spPr>
    </c:plotArea>
    <c:plotVisOnly val="1"/>
    <c:dispBlanksAs val="gap"/>
  </c:chart>
  <c:spPr>
    <a:noFill/>
    <a:ln w="9360">
      <a:noFill/>
    </a:ln>
  </c:sp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ayout>
        <c:manualLayout>
          <c:layoutTarget val="inner"/>
          <c:xMode val="edge"/>
          <c:yMode val="edge"/>
          <c:x val="0.151486486486487"/>
          <c:y val="0.0843478260869565"/>
          <c:w val="0.848378378378378"/>
          <c:h val="0.73369565217391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 w="0">
              <a:solidFill>
                <a:srgbClr val="000000"/>
              </a:solidFill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gapWidth val="30"/>
        <c:overlap val="0"/>
        <c:axId val="54394725"/>
        <c:axId val="99216325"/>
      </c:barChart>
      <c:catAx>
        <c:axId val="54394725"/>
        <c:scaling>
          <c:orientation val="minMax"/>
        </c:scaling>
        <c:delete val="0"/>
        <c:axPos val="b"/>
        <c:numFmt formatCode="[$-3409]mm/dd/yyyy" sourceLinked="1"/>
        <c:majorTickMark val="out"/>
        <c:minorTickMark val="none"/>
        <c:tickLblPos val="nextTo"/>
        <c:spPr>
          <a:ln w="93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99216325"/>
        <c:crosses val="autoZero"/>
        <c:auto val="1"/>
        <c:lblAlgn val="ctr"/>
        <c:lblOffset val="100"/>
        <c:noMultiLvlLbl val="0"/>
      </c:catAx>
      <c:valAx>
        <c:axId val="99216325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3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54394725"/>
        <c:crosses val="autoZero"/>
        <c:crossBetween val="between"/>
        <c:majorUnit val="20"/>
      </c:valAx>
      <c:spPr>
        <a:noFill/>
        <a:ln w="0">
          <a:noFill/>
        </a:ln>
      </c:spPr>
    </c:plotArea>
    <c:plotVisOnly val="1"/>
    <c:dispBlanksAs val="gap"/>
  </c:chart>
  <c:spPr>
    <a:noFill/>
    <a:ln w="9360">
      <a:noFill/>
    </a:ln>
  </c:spPr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ayout>
        <c:manualLayout>
          <c:layoutTarget val="inner"/>
          <c:xMode val="edge"/>
          <c:yMode val="edge"/>
          <c:x val="0.151486486486487"/>
          <c:y val="0.0843478260869565"/>
          <c:w val="0.834054054054054"/>
          <c:h val="0.73369565217391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 w="0">
              <a:solidFill>
                <a:srgbClr val="000000"/>
              </a:solidFill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gapWidth val="30"/>
        <c:overlap val="0"/>
        <c:axId val="60160960"/>
        <c:axId val="2756799"/>
      </c:barChart>
      <c:catAx>
        <c:axId val="60160960"/>
        <c:scaling>
          <c:orientation val="minMax"/>
        </c:scaling>
        <c:delete val="0"/>
        <c:axPos val="b"/>
        <c:numFmt formatCode="[$-3409]mm/dd/yyyy" sourceLinked="1"/>
        <c:majorTickMark val="out"/>
        <c:minorTickMark val="none"/>
        <c:tickLblPos val="nextTo"/>
        <c:spPr>
          <a:ln w="93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756799"/>
        <c:crosses val="autoZero"/>
        <c:auto val="1"/>
        <c:lblAlgn val="ctr"/>
        <c:lblOffset val="100"/>
        <c:noMultiLvlLbl val="0"/>
      </c:catAx>
      <c:valAx>
        <c:axId val="275679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3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60160960"/>
        <c:crosses val="autoZero"/>
        <c:crossBetween val="between"/>
      </c:valAx>
      <c:spPr>
        <a:noFill/>
        <a:ln w="0">
          <a:noFill/>
        </a:ln>
      </c:spPr>
    </c:plotArea>
    <c:plotVisOnly val="1"/>
    <c:dispBlanksAs val="gap"/>
  </c:chart>
  <c:spPr>
    <a:noFill/>
    <a:ln w="9360">
      <a:noFill/>
    </a:ln>
  </c:spPr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ayout>
        <c:manualLayout>
          <c:layoutTarget val="inner"/>
          <c:xMode val="edge"/>
          <c:yMode val="edge"/>
          <c:x val="0.151486486486487"/>
          <c:y val="0.0534782608695652"/>
          <c:w val="0.848378378378378"/>
          <c:h val="0.72586956521739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 w="0">
              <a:solidFill>
                <a:srgbClr val="000000"/>
              </a:solidFill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gapWidth val="30"/>
        <c:overlap val="0"/>
        <c:axId val="79752070"/>
        <c:axId val="23106181"/>
      </c:barChart>
      <c:catAx>
        <c:axId val="79752070"/>
        <c:scaling>
          <c:orientation val="minMax"/>
        </c:scaling>
        <c:delete val="0"/>
        <c:axPos val="b"/>
        <c:numFmt formatCode="[$-3409]mm/dd/yyyy" sourceLinked="1"/>
        <c:majorTickMark val="out"/>
        <c:minorTickMark val="none"/>
        <c:tickLblPos val="nextTo"/>
        <c:spPr>
          <a:ln w="93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3106181"/>
        <c:crosses val="autoZero"/>
        <c:auto val="1"/>
        <c:lblAlgn val="ctr"/>
        <c:lblOffset val="100"/>
        <c:noMultiLvlLbl val="0"/>
      </c:catAx>
      <c:valAx>
        <c:axId val="23106181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36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1" sz="1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79752070"/>
        <c:crosses val="autoZero"/>
        <c:crossBetween val="between"/>
        <c:majorUnit val="20"/>
      </c:valAx>
      <c:spPr>
        <a:noFill/>
        <a:ln w="0">
          <a:noFill/>
        </a:ln>
      </c:spPr>
    </c:plotArea>
    <c:plotVisOnly val="1"/>
    <c:dispBlanksAs val="gap"/>
  </c:chart>
  <c:spPr>
    <a:noFill/>
    <a:ln w="9360">
      <a:noFill/>
    </a:ln>
  </c:spPr>
</c:chartSpace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1371600" y="763200"/>
            <a:ext cx="5027760" cy="3770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96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77960" y="4776840"/>
            <a:ext cx="62164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0" y="-360"/>
            <a:ext cx="337176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head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3"/>
          </p:nvPr>
        </p:nvSpPr>
        <p:spPr>
          <a:xfrm>
            <a:off x="4398480" y="-360"/>
            <a:ext cx="3372120" cy="50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PH" sz="1400" spc="-1" strike="noStrike">
                <a:solidFill>
                  <a:srgbClr val="000000"/>
                </a:solidFill>
                <a:latin typeface="Times New Roman"/>
                <a:ea typeface="Arial Unicode MS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4"/>
          </p:nvPr>
        </p:nvSpPr>
        <p:spPr>
          <a:xfrm>
            <a:off x="0" y="9555120"/>
            <a:ext cx="337176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PH" sz="1400" spc="-1" strike="noStrike">
                <a:solidFill>
                  <a:srgbClr val="000000"/>
                </a:solidFill>
                <a:latin typeface="Times New Roman"/>
                <a:ea typeface="Arial Unicode MS"/>
              </a:defRPr>
            </a:lvl1pPr>
          </a:lstStyle>
          <a:p>
            <a: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5"/>
          </p:nvPr>
        </p:nvSpPr>
        <p:spPr>
          <a:xfrm>
            <a:off x="4398480" y="9555120"/>
            <a:ext cx="3372120" cy="50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PH" sz="1400" spc="-1" strike="noStrike">
                <a:solidFill>
                  <a:srgbClr val="000000"/>
                </a:solidFill>
                <a:latin typeface="Times New Roman"/>
                <a:ea typeface="Arial Unicode MS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00D3EE92-25C5-4EC4-8424-215D78B763A9}" type="slidenum">
              <a:rPr b="0" lang="en-PH" sz="14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0" y="0"/>
            <a:ext cx="1440" cy="144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0" y="-1101600"/>
            <a:ext cx="1440" cy="548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PH" sz="2000" spc="-1" strike="noStrike">
              <a:solidFill>
                <a:srgbClr val="000000"/>
              </a:solidFill>
              <a:latin typeface="Arial"/>
              <a:ea typeface="Microsoft YaHei"/>
            </a:endParaRPr>
          </a:p>
        </p:txBody>
      </p:sp>
      <p:sp>
        <p:nvSpPr>
          <p:cNvPr id="68" name=""/>
          <p:cNvSpPr/>
          <p:nvPr/>
        </p:nvSpPr>
        <p:spPr>
          <a:xfrm>
            <a:off x="0" y="0"/>
            <a:ext cx="1440" cy="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fld id="{C0BCEA27-BBFD-4C27-8B09-9A424B6006C9}" type="slidenum">
              <a:rPr b="0" lang="en-PH" sz="1800" spc="-1" strike="noStrike">
                <a:solidFill>
                  <a:srgbClr val="000000"/>
                </a:solidFill>
                <a:latin typeface="+mn-lt"/>
                <a:ea typeface="+mn-ea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C64157A-D657-4CB5-BEA8-AB80981B26D2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B9B8764-45EE-4CBF-BD9C-5B692E6475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D24FE96-4F9F-43DE-8D7E-81714A8DC3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817E5DC-9611-421C-91E4-9BDB5F8C3AB4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97C5DB9-80E4-480A-B106-DF8A6A4705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2C4FC53-C3FA-4B34-AD6B-092460DBF7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D4254F8-AA60-470D-A525-2A4C7AB571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1F64E21-20CC-4D95-90F6-B73C4C65EE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3C25F42-B571-43FF-9986-E73227241E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D312622-0E0F-49B6-A097-47DF79B614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24561FC-084F-4D7D-849B-BECEFB3CF2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25FAA72-2032-4338-9DE0-961E0EA9D7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96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96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343080" indent="-343080">
              <a:lnSpc>
                <a:spcPct val="96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343080" indent="-343080">
              <a:lnSpc>
                <a:spcPct val="96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343080" indent="-343080">
              <a:lnSpc>
                <a:spcPct val="96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343080" indent="-343080">
              <a:lnSpc>
                <a:spcPct val="96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343080" indent="-343080">
              <a:lnSpc>
                <a:spcPct val="96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343080" indent="-343080">
              <a:lnSpc>
                <a:spcPct val="96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  <a:defRPr b="0" lang="en-PH" sz="1800" spc="-1" strike="noStrike">
                <a:solidFill>
                  <a:srgbClr val="8b8b8b"/>
                </a:solidFill>
                <a:latin typeface="맑은 고딕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0" lang="en-PH" sz="1800" spc="-1" strike="noStrike">
                <a:solidFill>
                  <a:srgbClr val="8b8b8b"/>
                </a:solidFill>
                <a:latin typeface="맑은 고딕"/>
                <a:ea typeface="Arial Unicode MS"/>
              </a:rPr>
              <a:t>9/24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  <a:defRPr b="0" lang="en-PH" sz="1800" spc="-1" strike="noStrike">
                <a:solidFill>
                  <a:srgbClr val="8b8b8b"/>
                </a:solidFill>
                <a:latin typeface="맑은 고딕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fld id="{EF9983B8-B7B5-4F85-BC29-2C80E699B53A}" type="slidenum">
              <a:rPr b="0" lang="en-PH" sz="1800" spc="-1" strike="noStrike">
                <a:solidFill>
                  <a:srgbClr val="8b8b8b"/>
                </a:solidFill>
                <a:latin typeface="맑은 고딕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chart" Target="../charts/chart2.xml"/><Relationship Id="rId3" Type="http://schemas.openxmlformats.org/officeDocument/2006/relationships/chart" Target="../charts/chart3.xml"/><Relationship Id="rId4" Type="http://schemas.openxmlformats.org/officeDocument/2006/relationships/chart" Target="../charts/chart4.xml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1618560" y="907920"/>
            <a:ext cx="5663160" cy="3687840"/>
            <a:chOff x="1618560" y="907920"/>
            <a:chExt cx="5663160" cy="3687840"/>
          </a:xfrm>
        </p:grpSpPr>
        <p:graphicFrame>
          <p:nvGraphicFramePr>
            <p:cNvPr id="49" name=""/>
            <p:cNvGraphicFramePr/>
            <p:nvPr/>
          </p:nvGraphicFramePr>
          <p:xfrm>
            <a:off x="4619520" y="2933640"/>
            <a:ext cx="2662200" cy="1654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"/>
            </a:graphicData>
          </a:graphic>
        </p:graphicFrame>
        <p:graphicFrame>
          <p:nvGraphicFramePr>
            <p:cNvPr id="50" name=""/>
            <p:cNvGraphicFramePr/>
            <p:nvPr/>
          </p:nvGraphicFramePr>
          <p:xfrm>
            <a:off x="1741320" y="2941560"/>
            <a:ext cx="2662560" cy="1654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1" name=""/>
            <p:cNvGraphicFramePr/>
            <p:nvPr/>
          </p:nvGraphicFramePr>
          <p:xfrm>
            <a:off x="4608360" y="1031760"/>
            <a:ext cx="2662560" cy="1654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2" name=""/>
            <p:cNvGraphicFramePr/>
            <p:nvPr/>
          </p:nvGraphicFramePr>
          <p:xfrm>
            <a:off x="1736640" y="1066680"/>
            <a:ext cx="2662200" cy="1654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3" name=""/>
            <p:cNvSpPr/>
            <p:nvPr/>
          </p:nvSpPr>
          <p:spPr>
            <a:xfrm>
              <a:off x="2939400" y="2820960"/>
              <a:ext cx="44136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AK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854760" y="1353960"/>
              <a:ext cx="20952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rot="10800000">
              <a:off x="1618560" y="1919160"/>
              <a:ext cx="152640" cy="160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b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Relative mRNA express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441600" y="1401840"/>
              <a:ext cx="20952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451320" y="3479760"/>
              <a:ext cx="20952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025880" y="3379680"/>
              <a:ext cx="20952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843520" y="2820960"/>
              <a:ext cx="59688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GLUT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902280" y="3565440"/>
              <a:ext cx="20988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6324480" y="3505320"/>
              <a:ext cx="20952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016520" y="1009800"/>
              <a:ext cx="20952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861280" y="907920"/>
              <a:ext cx="50364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IRS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730840" y="909000"/>
              <a:ext cx="76356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2396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  <a:tab algn="l" pos="9434520"/>
                </a:tabLst>
              </a:pPr>
              <a:r>
                <a:rPr b="1" lang="en-PH" sz="1000" spc="-1" strike="noStrike">
                  <a:solidFill>
                    <a:srgbClr val="000000"/>
                  </a:solidFill>
                  <a:latin typeface="Arial"/>
                </a:rPr>
                <a:t>IRS-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"/>
          <p:cNvSpPr/>
          <p:nvPr/>
        </p:nvSpPr>
        <p:spPr>
          <a:xfrm>
            <a:off x="120600" y="5300640"/>
            <a:ext cx="8856720" cy="115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PH" sz="1400" spc="-1" strike="noStrike">
                <a:solidFill>
                  <a:srgbClr val="000000"/>
                </a:solidFill>
                <a:latin typeface="맑은 고딕"/>
              </a:rPr>
              <a:t>Figure S1</a:t>
            </a:r>
            <a:r>
              <a:rPr b="0" lang="en-PH" sz="1400" spc="-1" strike="noStrike">
                <a:solidFill>
                  <a:srgbClr val="000000"/>
                </a:solidFill>
                <a:latin typeface="맑은 고딕"/>
              </a:rPr>
              <a:t>. </a:t>
            </a:r>
            <a:r>
              <a:rPr b="1" lang="en-PH" sz="1400" spc="-1" strike="noStrike">
                <a:solidFill>
                  <a:srgbClr val="000000"/>
                </a:solidFill>
                <a:latin typeface="맑은 고딕"/>
              </a:rPr>
              <a:t>Effects of </a:t>
            </a:r>
            <a:r>
              <a:rPr b="1" i="1" lang="en-PH" sz="1400" spc="-1" strike="noStrike">
                <a:solidFill>
                  <a:srgbClr val="000000"/>
                </a:solidFill>
                <a:latin typeface="맑은 고딕"/>
              </a:rPr>
              <a:t>Aralia elata</a:t>
            </a:r>
            <a:r>
              <a:rPr b="1" lang="en-PH" sz="1400" spc="-1" strike="noStrike">
                <a:solidFill>
                  <a:srgbClr val="000000"/>
                </a:solidFill>
                <a:latin typeface="맑은 고딕"/>
              </a:rPr>
              <a:t> (Miq) </a:t>
            </a:r>
            <a:r>
              <a:rPr b="1" i="1" lang="en-PH" sz="1400" spc="-1" strike="noStrike">
                <a:solidFill>
                  <a:srgbClr val="000000"/>
                </a:solidFill>
                <a:latin typeface="맑은 고딕"/>
              </a:rPr>
              <a:t>Seem</a:t>
            </a:r>
            <a:r>
              <a:rPr b="1" lang="en-PH" sz="1400" spc="-1" strike="noStrike">
                <a:solidFill>
                  <a:srgbClr val="000000"/>
                </a:solidFill>
                <a:latin typeface="맑은 고딕"/>
              </a:rPr>
              <a:t> (AE) on insulin signaling-associated genes in HepG2 cells. </a:t>
            </a:r>
            <a:r>
              <a:rPr b="0" lang="en-PH" sz="1400" spc="-1" strike="noStrike">
                <a:solidFill>
                  <a:srgbClr val="000000"/>
                </a:solidFill>
                <a:latin typeface="맑은 고딕"/>
              </a:rPr>
              <a:t>HepG2 cells were treated with 100 μg/mL AE and OA. After treatment for 24h, RNA was isolated and reverse transcribed for RTPCR analysis using the primers described in materials and methods. Results are the mean ± SEM. *p&lt;0.05 compared with the OA group. DMEM, control group; OA, oleic acid-treated group; RV, OA+ resveratrol-treated group; AE, OA+ </a:t>
            </a:r>
            <a:r>
              <a:rPr b="0" i="1" lang="en-PH" sz="1400" spc="-1" strike="noStrike">
                <a:solidFill>
                  <a:srgbClr val="000000"/>
                </a:solidFill>
                <a:latin typeface="맑은 고딕"/>
              </a:rPr>
              <a:t>Aralia elata</a:t>
            </a:r>
            <a:r>
              <a:rPr b="0" lang="en-PH" sz="1400" spc="-1" strike="noStrike">
                <a:solidFill>
                  <a:srgbClr val="000000"/>
                </a:solidFill>
                <a:latin typeface="맑은 고딕"/>
              </a:rPr>
              <a:t> (Miq) </a:t>
            </a:r>
            <a:r>
              <a:rPr b="0" i="1" lang="en-PH" sz="1400" spc="-1" strike="noStrike">
                <a:solidFill>
                  <a:srgbClr val="000000"/>
                </a:solidFill>
                <a:latin typeface="맑은 고딕"/>
              </a:rPr>
              <a:t>Seem</a:t>
            </a:r>
            <a:r>
              <a:rPr b="0" lang="en-PH" sz="1400" spc="-1" strike="noStrike">
                <a:solidFill>
                  <a:srgbClr val="000000"/>
                </a:solidFill>
                <a:latin typeface="맑은 고딕"/>
              </a:rPr>
              <a:t>-treated group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